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106280" y="812880"/>
            <a:ext cx="5343480" cy="400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81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4"/>
          </p:nvPr>
        </p:nvSpPr>
        <p:spPr>
          <a:xfrm>
            <a:off x="4280040" y="0"/>
            <a:ext cx="32781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10156680"/>
            <a:ext cx="32781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280040" y="10156680"/>
            <a:ext cx="32781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E8110556-8E2C-441D-90CD-C303425E16D4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6"/>
          <p:cNvSpPr/>
          <p:nvPr/>
        </p:nvSpPr>
        <p:spPr>
          <a:xfrm>
            <a:off x="4280040" y="10156680"/>
            <a:ext cx="32781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899081E2-B25C-4BD7-B298-B102E73CFAD7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F83D0-E86F-4619-8C8B-E2CDE5BF39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557D4-9C39-4108-AF73-DE0488CE93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60854-DBF7-4077-A312-539C60F3FA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5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5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02E5C-987E-4F87-992F-1FA42CF89A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0D93B-CE4A-4756-83B8-8F3F5C7436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CA66F-2F24-407F-A071-D668EB2D3B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1EC80-6ABE-4426-9018-4E05F01369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AAA05-2B85-4DAB-8028-023C2FFEE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6948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7CD83-219E-4A4A-BE47-087493FDDF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F9BFE1-8308-4B42-87C5-F73C3606C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B61C0-A7B7-49AA-B3AC-E4600A7095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197DDF-1F04-42DF-B364-219A2BE9AB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61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39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6280" y="6886440"/>
            <a:ext cx="234648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fld id="{A6064660-9C1D-45DB-A648-95E1E581381F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" descr="http://www.rcsb.org/pdb/explorer/images/spacer.gif"/>
          <p:cNvPicPr/>
          <p:nvPr/>
        </p:nvPicPr>
        <p:blipFill>
          <a:blip r:embed="rId1"/>
          <a:stretch/>
        </p:blipFill>
        <p:spPr>
          <a:xfrm>
            <a:off x="2496960" y="2770200"/>
            <a:ext cx="8280" cy="7920"/>
          </a:xfrm>
          <a:prstGeom prst="rect">
            <a:avLst/>
          </a:prstGeom>
          <a:ln w="0">
            <a:noFill/>
          </a:ln>
        </p:spPr>
      </p:pic>
      <p:sp>
        <p:nvSpPr>
          <p:cNvPr id="49" name="Text Box 7"/>
          <p:cNvSpPr/>
          <p:nvPr/>
        </p:nvSpPr>
        <p:spPr>
          <a:xfrm>
            <a:off x="6375240" y="3790800"/>
            <a:ext cx="925920" cy="40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ull d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lot : G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8"/>
          <p:cNvSpPr/>
          <p:nvPr/>
        </p:nvSpPr>
        <p:spPr>
          <a:xfrm>
            <a:off x="6372360" y="3070080"/>
            <a:ext cx="90144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ull d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lot : Fl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1" descr="flag_gst_3em"/>
          <p:cNvPicPr/>
          <p:nvPr/>
        </p:nvPicPr>
        <p:blipFill>
          <a:blip r:embed="rId2"/>
          <a:stretch/>
        </p:blipFill>
        <p:spPr>
          <a:xfrm>
            <a:off x="5892840" y="3479760"/>
            <a:ext cx="496800" cy="10209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2" descr="04-04-08 bis (30 sec)"/>
          <p:cNvPicPr/>
          <p:nvPr/>
        </p:nvPicPr>
        <p:blipFill>
          <a:blip r:embed="rId3"/>
          <a:srcRect l="41654" t="0" r="5951" b="0"/>
          <a:stretch/>
        </p:blipFill>
        <p:spPr>
          <a:xfrm>
            <a:off x="5899320" y="4546440"/>
            <a:ext cx="496800" cy="2984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3" descr="04-04-08 bis (30 sec)"/>
          <p:cNvPicPr/>
          <p:nvPr/>
        </p:nvPicPr>
        <p:blipFill>
          <a:blip r:embed="rId4"/>
          <a:srcRect l="0" t="0" r="53555" b="0"/>
          <a:stretch/>
        </p:blipFill>
        <p:spPr>
          <a:xfrm>
            <a:off x="5899320" y="3071880"/>
            <a:ext cx="496800" cy="342720"/>
          </a:xfrm>
          <a:prstGeom prst="rect">
            <a:avLst/>
          </a:prstGeom>
          <a:ln w="0">
            <a:noFill/>
          </a:ln>
        </p:spPr>
      </p:pic>
      <p:sp>
        <p:nvSpPr>
          <p:cNvPr id="54" name="Text Box 15"/>
          <p:cNvSpPr/>
          <p:nvPr/>
        </p:nvSpPr>
        <p:spPr>
          <a:xfrm>
            <a:off x="6371640" y="4487760"/>
            <a:ext cx="938160" cy="40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ell lys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lot : Fl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16" descr="04-04-08 (30 sec)"/>
          <p:cNvPicPr/>
          <p:nvPr/>
        </p:nvPicPr>
        <p:blipFill>
          <a:blip r:embed="rId5"/>
          <a:srcRect l="23157" t="90691" r="3860" b="0"/>
          <a:stretch/>
        </p:blipFill>
        <p:spPr>
          <a:xfrm>
            <a:off x="4567320" y="4546440"/>
            <a:ext cx="496800" cy="2984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7" descr="04-04-08 (30 sec)"/>
          <p:cNvPicPr/>
          <p:nvPr/>
        </p:nvPicPr>
        <p:blipFill>
          <a:blip r:embed="rId6"/>
          <a:srcRect l="15438" t="2296" r="7719" b="86100"/>
          <a:stretch/>
        </p:blipFill>
        <p:spPr>
          <a:xfrm>
            <a:off x="3246480" y="4538520"/>
            <a:ext cx="500040" cy="3002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8" descr="flag_gst_2em"/>
          <p:cNvPicPr/>
          <p:nvPr/>
        </p:nvPicPr>
        <p:blipFill>
          <a:blip r:embed="rId7"/>
          <a:srcRect l="0" t="25848" r="77571" b="38805"/>
          <a:stretch/>
        </p:blipFill>
        <p:spPr>
          <a:xfrm>
            <a:off x="4567320" y="3071880"/>
            <a:ext cx="496800" cy="3427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9" descr="flag_gst_2em"/>
          <p:cNvPicPr/>
          <p:nvPr/>
        </p:nvPicPr>
        <p:blipFill>
          <a:blip r:embed="rId8"/>
          <a:srcRect l="77571" t="0" r="0" b="0"/>
          <a:stretch/>
        </p:blipFill>
        <p:spPr>
          <a:xfrm>
            <a:off x="4567320" y="3479760"/>
            <a:ext cx="496800" cy="10177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0" descr="flag_1ere manip_ns3_hel_dv2"/>
          <p:cNvPicPr/>
          <p:nvPr/>
        </p:nvPicPr>
        <p:blipFill>
          <a:blip r:embed="rId9"/>
          <a:stretch/>
        </p:blipFill>
        <p:spPr>
          <a:xfrm>
            <a:off x="3246480" y="3071880"/>
            <a:ext cx="493560" cy="3412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1" descr="flag_gst_2em"/>
          <p:cNvPicPr/>
          <p:nvPr/>
        </p:nvPicPr>
        <p:blipFill>
          <a:blip r:embed="rId10"/>
          <a:srcRect l="6333" t="3087" r="6333" b="3087"/>
          <a:stretch/>
        </p:blipFill>
        <p:spPr>
          <a:xfrm>
            <a:off x="3246480" y="3479760"/>
            <a:ext cx="496800" cy="1017720"/>
          </a:xfrm>
          <a:prstGeom prst="rect">
            <a:avLst/>
          </a:prstGeom>
          <a:ln w="0">
            <a:noFill/>
          </a:ln>
        </p:spPr>
      </p:pic>
      <p:sp>
        <p:nvSpPr>
          <p:cNvPr id="61" name="Text Box 22"/>
          <p:cNvSpPr/>
          <p:nvPr/>
        </p:nvSpPr>
        <p:spPr>
          <a:xfrm>
            <a:off x="3624480" y="3122640"/>
            <a:ext cx="798120" cy="40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FKB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3"/>
          <p:cNvSpPr/>
          <p:nvPr/>
        </p:nvSpPr>
        <p:spPr>
          <a:xfrm>
            <a:off x="5197320" y="3124080"/>
            <a:ext cx="511560" cy="40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ZI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4"/>
          <p:cNvSpPr/>
          <p:nvPr/>
        </p:nvSpPr>
        <p:spPr>
          <a:xfrm>
            <a:off x="2382840" y="3110040"/>
            <a:ext cx="671400" cy="25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AF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"/>
          <p:cNvSpPr/>
          <p:nvPr/>
        </p:nvSpPr>
        <p:spPr>
          <a:xfrm>
            <a:off x="2968560" y="438948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8"/>
          <p:cNvSpPr/>
          <p:nvPr/>
        </p:nvSpPr>
        <p:spPr>
          <a:xfrm>
            <a:off x="2117520" y="4245120"/>
            <a:ext cx="936720" cy="25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ST alo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9"/>
          <p:cNvSpPr/>
          <p:nvPr/>
        </p:nvSpPr>
        <p:spPr>
          <a:xfrm>
            <a:off x="3002040" y="364644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1932120" y="3502080"/>
            <a:ext cx="1125720" cy="25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8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S3 helic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1"/>
          <p:cNvSpPr/>
          <p:nvPr/>
        </p:nvSpPr>
        <p:spPr>
          <a:xfrm rot="16200000">
            <a:off x="2827800" y="2304000"/>
            <a:ext cx="11257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S3 helic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2"/>
          <p:cNvSpPr/>
          <p:nvPr/>
        </p:nvSpPr>
        <p:spPr>
          <a:xfrm rot="16200000">
            <a:off x="4151880" y="2304000"/>
            <a:ext cx="11257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S3 helic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 rot="16200000">
            <a:off x="5486760" y="2305440"/>
            <a:ext cx="11257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S3 helic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4"/>
          <p:cNvSpPr/>
          <p:nvPr/>
        </p:nvSpPr>
        <p:spPr>
          <a:xfrm rot="16200000">
            <a:off x="3346920" y="2614320"/>
            <a:ext cx="49464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 rot="16200000">
            <a:off x="4670640" y="2614320"/>
            <a:ext cx="49464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6"/>
          <p:cNvSpPr/>
          <p:nvPr/>
        </p:nvSpPr>
        <p:spPr>
          <a:xfrm rot="16200000">
            <a:off x="5994720" y="2614320"/>
            <a:ext cx="49464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7"/>
          <p:cNvSpPr/>
          <p:nvPr/>
        </p:nvSpPr>
        <p:spPr>
          <a:xfrm>
            <a:off x="3013200" y="325296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8"/>
          <p:cNvSpPr/>
          <p:nvPr/>
        </p:nvSpPr>
        <p:spPr>
          <a:xfrm>
            <a:off x="4351320" y="325296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9"/>
          <p:cNvSpPr/>
          <p:nvPr/>
        </p:nvSpPr>
        <p:spPr>
          <a:xfrm>
            <a:off x="5649840" y="325296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0"/>
          <p:cNvSpPr/>
          <p:nvPr/>
        </p:nvSpPr>
        <p:spPr>
          <a:xfrm>
            <a:off x="3247920" y="2998800"/>
            <a:ext cx="459000" cy="0"/>
          </a:xfrm>
          <a:prstGeom prst="line">
            <a:avLst/>
          </a:prstGeom>
          <a:ln w="190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2"/>
          <p:cNvSpPr/>
          <p:nvPr/>
        </p:nvSpPr>
        <p:spPr>
          <a:xfrm>
            <a:off x="4589640" y="2998800"/>
            <a:ext cx="458640" cy="0"/>
          </a:xfrm>
          <a:prstGeom prst="line">
            <a:avLst/>
          </a:prstGeom>
          <a:ln w="190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3"/>
          <p:cNvSpPr/>
          <p:nvPr/>
        </p:nvSpPr>
        <p:spPr>
          <a:xfrm>
            <a:off x="5910120" y="2998800"/>
            <a:ext cx="459000" cy="0"/>
          </a:xfrm>
          <a:prstGeom prst="line">
            <a:avLst/>
          </a:prstGeom>
          <a:ln w="190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3T15:18:16Z</dcterms:created>
  <dc:creator>Laurène</dc:creator>
  <dc:description/>
  <dc:language>en-US</dc:language>
  <cp:lastModifiedBy>nathalie</cp:lastModifiedBy>
  <dcterms:modified xsi:type="dcterms:W3CDTF">2011-09-27T08:52:15Z</dcterms:modified>
  <cp:revision>4</cp:revision>
  <dc:subject/>
  <dc:title>Diapositive 1</dc:title>
</cp:coreProperties>
</file>